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9" r:id="rId4"/>
    <p:sldId id="260" r:id="rId5"/>
    <p:sldId id="263" r:id="rId6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Estilo Médio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Estilo Claro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0" autoAdjust="0"/>
    <p:restoredTop sz="94660"/>
  </p:normalViewPr>
  <p:slideViewPr>
    <p:cSldViewPr snapToGrid="0">
      <p:cViewPr varScale="1">
        <p:scale>
          <a:sx n="50" d="100"/>
          <a:sy n="50" d="100"/>
        </p:scale>
        <p:origin x="2824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4/02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102547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4/02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12350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4/02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11467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4/02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50189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4/02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72032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4/02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05804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4/02/2023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20936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4/02/2023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5134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4/02/2023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26176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4/02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489858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4/02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82079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14EC12-37C6-42E2-B85E-8644641177F5}" type="datetimeFigureOut">
              <a:rPr lang="pt-BR" smtClean="0"/>
              <a:t>24/02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AA3250-EF65-4344-8BBC-BE0AAEEC16F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467558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tiff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>
            <a:extLst>
              <a:ext uri="{FF2B5EF4-FFF2-40B4-BE49-F238E27FC236}">
                <a16:creationId xmlns:a16="http://schemas.microsoft.com/office/drawing/2014/main" id="{A9F851BD-B5F2-02FA-F6F1-071839D7F92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1628" y="2228409"/>
            <a:ext cx="3836756" cy="30529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Flowchart: Merge 104">
            <a:extLst>
              <a:ext uri="{FF2B5EF4-FFF2-40B4-BE49-F238E27FC236}">
                <a16:creationId xmlns:a16="http://schemas.microsoft.com/office/drawing/2014/main" id="{04F52805-1FB6-0376-0799-BA5D7B835EFC}"/>
              </a:ext>
            </a:extLst>
          </p:cNvPr>
          <p:cNvSpPr/>
          <p:nvPr/>
        </p:nvSpPr>
        <p:spPr bwMode="auto">
          <a:xfrm rot="16200000">
            <a:off x="673879" y="3981485"/>
            <a:ext cx="171450" cy="107950"/>
          </a:xfrm>
          <a:prstGeom prst="flowChartMerge">
            <a:avLst/>
          </a:prstGeom>
          <a:solidFill>
            <a:schemeClr val="tx1"/>
          </a:solidFill>
          <a:ln w="3175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pt-BR"/>
          </a:p>
        </p:txBody>
      </p:sp>
      <p:sp>
        <p:nvSpPr>
          <p:cNvPr id="31" name="TextBox 105">
            <a:extLst>
              <a:ext uri="{FF2B5EF4-FFF2-40B4-BE49-F238E27FC236}">
                <a16:creationId xmlns:a16="http://schemas.microsoft.com/office/drawing/2014/main" id="{AE4760CA-EA8A-DAA9-7415-72B09A939B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54" y="3884789"/>
            <a:ext cx="721538" cy="3231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sz="1500">
                <a:latin typeface="Calibri" panose="020F0502020204030204" pitchFamily="34" charset="0"/>
              </a:rPr>
              <a:t>15 kDa</a:t>
            </a:r>
          </a:p>
        </p:txBody>
      </p:sp>
      <p:sp>
        <p:nvSpPr>
          <p:cNvPr id="28" name="CaixaDeTexto 36">
            <a:extLst>
              <a:ext uri="{FF2B5EF4-FFF2-40B4-BE49-F238E27FC236}">
                <a16:creationId xmlns:a16="http://schemas.microsoft.com/office/drawing/2014/main" id="{59375CCD-DE25-BB3A-CE4F-8660FFD4FD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98567" y="1939894"/>
            <a:ext cx="475236" cy="3693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sz="1800" dirty="0">
                <a:latin typeface="Calibri" panose="020F0502020204030204" pitchFamily="34" charset="0"/>
              </a:rPr>
              <a:t>IEC</a:t>
            </a:r>
          </a:p>
        </p:txBody>
      </p:sp>
      <p:sp>
        <p:nvSpPr>
          <p:cNvPr id="29" name="TextBox 8">
            <a:extLst>
              <a:ext uri="{FF2B5EF4-FFF2-40B4-BE49-F238E27FC236}">
                <a16:creationId xmlns:a16="http://schemas.microsoft.com/office/drawing/2014/main" id="{313B50DF-09E6-A520-398B-22439EA947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479" y="1937910"/>
            <a:ext cx="1094790" cy="3693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sz="1800">
                <a:latin typeface="Calibri" panose="020F0502020204030204" pitchFamily="34" charset="0"/>
              </a:rPr>
              <a:t>Pre</a:t>
            </a:r>
          </a:p>
        </p:txBody>
      </p:sp>
      <p:sp>
        <p:nvSpPr>
          <p:cNvPr id="27" name="TextBox 101">
            <a:extLst>
              <a:ext uri="{FF2B5EF4-FFF2-40B4-BE49-F238E27FC236}">
                <a16:creationId xmlns:a16="http://schemas.microsoft.com/office/drawing/2014/main" id="{13E8FA13-3146-59F3-D27C-E9E2E0AD5A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67567" y="1949781"/>
            <a:ext cx="1094790" cy="3693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sz="1800">
                <a:latin typeface="Calibri" panose="020F0502020204030204" pitchFamily="34" charset="0"/>
              </a:rPr>
              <a:t>Pos</a:t>
            </a:r>
          </a:p>
        </p:txBody>
      </p:sp>
      <p:pic>
        <p:nvPicPr>
          <p:cNvPr id="19" name="Picture 92">
            <a:extLst>
              <a:ext uri="{FF2B5EF4-FFF2-40B4-BE49-F238E27FC236}">
                <a16:creationId xmlns:a16="http://schemas.microsoft.com/office/drawing/2014/main" id="{B5F50E9C-3C12-6A55-7C10-76DA1AF77E3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3000"/>
          <a:stretch>
            <a:fillRect/>
          </a:stretch>
        </p:blipFill>
        <p:spPr bwMode="auto">
          <a:xfrm>
            <a:off x="7710311" y="2298853"/>
            <a:ext cx="582226" cy="2516069"/>
          </a:xfrm>
          <a:prstGeom prst="rect">
            <a:avLst/>
          </a:prstGeom>
          <a:noFill/>
          <a:ln w="254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20" name="Group 93">
            <a:extLst>
              <a:ext uri="{FF2B5EF4-FFF2-40B4-BE49-F238E27FC236}">
                <a16:creationId xmlns:a16="http://schemas.microsoft.com/office/drawing/2014/main" id="{62F9E2DC-DB97-5417-D64E-9126D658B30A}"/>
              </a:ext>
            </a:extLst>
          </p:cNvPr>
          <p:cNvGrpSpPr>
            <a:grpSpLocks/>
          </p:cNvGrpSpPr>
          <p:nvPr/>
        </p:nvGrpSpPr>
        <p:grpSpPr bwMode="auto">
          <a:xfrm>
            <a:off x="6863782" y="3321563"/>
            <a:ext cx="774534" cy="323179"/>
            <a:chOff x="5597522" y="4758497"/>
            <a:chExt cx="774678" cy="323165"/>
          </a:xfrm>
        </p:grpSpPr>
        <p:sp>
          <p:nvSpPr>
            <p:cNvPr id="24" name="Flowchart: Merge 98">
              <a:extLst>
                <a:ext uri="{FF2B5EF4-FFF2-40B4-BE49-F238E27FC236}">
                  <a16:creationId xmlns:a16="http://schemas.microsoft.com/office/drawing/2014/main" id="{C9B5C1AA-9CA7-D866-C758-B9604761BED5}"/>
                </a:ext>
              </a:extLst>
            </p:cNvPr>
            <p:cNvSpPr/>
            <p:nvPr/>
          </p:nvSpPr>
          <p:spPr>
            <a:xfrm rot="16200000">
              <a:off x="6231625" y="4865158"/>
              <a:ext cx="173031" cy="107970"/>
            </a:xfrm>
            <a:prstGeom prst="flowChartMerge">
              <a:avLst/>
            </a:prstGeom>
            <a:solidFill>
              <a:schemeClr val="tx1"/>
            </a:solidFill>
            <a:ln w="3175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BR"/>
            </a:p>
          </p:txBody>
        </p:sp>
        <p:sp>
          <p:nvSpPr>
            <p:cNvPr id="25" name="TextBox 99">
              <a:extLst>
                <a:ext uri="{FF2B5EF4-FFF2-40B4-BE49-F238E27FC236}">
                  <a16:creationId xmlns:a16="http://schemas.microsoft.com/office/drawing/2014/main" id="{A0DF754A-89AA-4F0B-6BF5-177D23C4546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97522" y="4758497"/>
              <a:ext cx="721672" cy="3231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pt-BR" altLang="pt-BR" sz="1500">
                  <a:latin typeface="Calibri" panose="020F0502020204030204" pitchFamily="34" charset="0"/>
                </a:rPr>
                <a:t>15 kDa</a:t>
              </a:r>
            </a:p>
          </p:txBody>
        </p:sp>
      </p:grpSp>
      <p:sp>
        <p:nvSpPr>
          <p:cNvPr id="21" name="TextBox 94">
            <a:extLst>
              <a:ext uri="{FF2B5EF4-FFF2-40B4-BE49-F238E27FC236}">
                <a16:creationId xmlns:a16="http://schemas.microsoft.com/office/drawing/2014/main" id="{058FEEC4-CA4A-AC53-6934-D01BCB63C8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29491" y="1981211"/>
            <a:ext cx="301630" cy="3693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sz="1800" b="1">
                <a:latin typeface="Calibri" panose="020F0502020204030204" pitchFamily="34" charset="0"/>
              </a:rPr>
              <a:t>1</a:t>
            </a:r>
          </a:p>
        </p:txBody>
      </p:sp>
      <p:pic>
        <p:nvPicPr>
          <p:cNvPr id="22" name="Imagem 111" descr="westenbvlotti.tif">
            <a:extLst>
              <a:ext uri="{FF2B5EF4-FFF2-40B4-BE49-F238E27FC236}">
                <a16:creationId xmlns:a16="http://schemas.microsoft.com/office/drawing/2014/main" id="{0705F4F7-DF1E-3ACE-1DBC-C924ED50EBC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13323" y="2307235"/>
            <a:ext cx="455802" cy="2520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" name="CaixaDeTexto 42">
            <a:extLst>
              <a:ext uri="{FF2B5EF4-FFF2-40B4-BE49-F238E27FC236}">
                <a16:creationId xmlns:a16="http://schemas.microsoft.com/office/drawing/2014/main" id="{8D66BF53-FF21-BC84-1C77-031EB4C6BD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64527" y="1978154"/>
            <a:ext cx="551652" cy="4001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sz="2000">
                <a:latin typeface="Calibri" panose="020F0502020204030204" pitchFamily="34" charset="0"/>
              </a:rPr>
              <a:t>WB</a:t>
            </a:r>
          </a:p>
        </p:txBody>
      </p:sp>
      <p:sp>
        <p:nvSpPr>
          <p:cNvPr id="15" name="Rectangle 77">
            <a:extLst>
              <a:ext uri="{FF2B5EF4-FFF2-40B4-BE49-F238E27FC236}">
                <a16:creationId xmlns:a16="http://schemas.microsoft.com/office/drawing/2014/main" id="{E76FD661-84BF-A63B-48DC-F6F26EEC4E6A}"/>
              </a:ext>
            </a:extLst>
          </p:cNvPr>
          <p:cNvSpPr/>
          <p:nvPr/>
        </p:nvSpPr>
        <p:spPr bwMode="auto">
          <a:xfrm>
            <a:off x="5383991" y="5113372"/>
            <a:ext cx="561975" cy="2190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pt-BR" dirty="0"/>
          </a:p>
        </p:txBody>
      </p:sp>
      <p:sp>
        <p:nvSpPr>
          <p:cNvPr id="9" name="TextBox 62">
            <a:extLst>
              <a:ext uri="{FF2B5EF4-FFF2-40B4-BE49-F238E27FC236}">
                <a16:creationId xmlns:a16="http://schemas.microsoft.com/office/drawing/2014/main" id="{464BC115-6831-33E8-D373-1A0645CDDE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316" y="1566897"/>
            <a:ext cx="433132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A</a:t>
            </a:r>
          </a:p>
        </p:txBody>
      </p:sp>
      <p:pic>
        <p:nvPicPr>
          <p:cNvPr id="12" name="Picture 2">
            <a:extLst>
              <a:ext uri="{FF2B5EF4-FFF2-40B4-BE49-F238E27FC236}">
                <a16:creationId xmlns:a16="http://schemas.microsoft.com/office/drawing/2014/main" id="{E09FB98E-7D26-F1A4-76CD-5B56EE6B6EC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81" t="2325" r="5473" b="5247"/>
          <a:stretch>
            <a:fillRect/>
          </a:stretch>
        </p:blipFill>
        <p:spPr bwMode="auto">
          <a:xfrm>
            <a:off x="879671" y="2293503"/>
            <a:ext cx="990177" cy="2458887"/>
          </a:xfrm>
          <a:prstGeom prst="rect">
            <a:avLst/>
          </a:prstGeom>
          <a:noFill/>
          <a:ln w="254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7">
            <a:extLst>
              <a:ext uri="{FF2B5EF4-FFF2-40B4-BE49-F238E27FC236}">
                <a16:creationId xmlns:a16="http://schemas.microsoft.com/office/drawing/2014/main" id="{3B20D820-C307-4CBB-5074-509FA7C9A9F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447" r="18301"/>
          <a:stretch>
            <a:fillRect/>
          </a:stretch>
        </p:blipFill>
        <p:spPr bwMode="auto">
          <a:xfrm>
            <a:off x="2050053" y="2292679"/>
            <a:ext cx="392914" cy="2447011"/>
          </a:xfrm>
          <a:prstGeom prst="rect">
            <a:avLst/>
          </a:prstGeom>
          <a:noFill/>
          <a:ln w="254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Rectangle 5">
            <a:extLst>
              <a:ext uri="{FF2B5EF4-FFF2-40B4-BE49-F238E27FC236}">
                <a16:creationId xmlns:a16="http://schemas.microsoft.com/office/drawing/2014/main" id="{610B84EE-F36E-E28B-22F4-7B47C6D73D8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5912629" y="6474907"/>
            <a:ext cx="16224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l-GR" altLang="pt-BR" sz="1800" b="1" dirty="0">
                <a:latin typeface="Calibri" panose="020F0502020204030204" pitchFamily="34" charset="0"/>
              </a:rPr>
              <a:t>α</a:t>
            </a:r>
            <a:r>
              <a:rPr lang="pt-BR" altLang="pt-BR" sz="1800" b="1" dirty="0">
                <a:latin typeface="Calibri" panose="020F0502020204030204" pitchFamily="34" charset="0"/>
              </a:rPr>
              <a:t>-</a:t>
            </a:r>
            <a:r>
              <a:rPr lang="pt-BR" altLang="pt-BR" sz="1800" b="1" dirty="0" err="1">
                <a:latin typeface="Calibri" panose="020F0502020204030204" pitchFamily="34" charset="0"/>
              </a:rPr>
              <a:t>sin</a:t>
            </a:r>
            <a:r>
              <a:rPr lang="pt-BR" altLang="pt-BR" sz="1800" b="1" dirty="0">
                <a:latin typeface="Calibri" panose="020F0502020204030204" pitchFamily="34" charset="0"/>
              </a:rPr>
              <a:t> A30P 10d</a:t>
            </a:r>
          </a:p>
        </p:txBody>
      </p:sp>
      <p:pic>
        <p:nvPicPr>
          <p:cNvPr id="35" name="Picture 8">
            <a:extLst>
              <a:ext uri="{FF2B5EF4-FFF2-40B4-BE49-F238E27FC236}">
                <a16:creationId xmlns:a16="http://schemas.microsoft.com/office/drawing/2014/main" id="{D605CA73-B0B2-E328-3873-77A4F7248A7B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82591" y="5614482"/>
            <a:ext cx="2478796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45" name="Agrupar 44">
            <a:extLst>
              <a:ext uri="{FF2B5EF4-FFF2-40B4-BE49-F238E27FC236}">
                <a16:creationId xmlns:a16="http://schemas.microsoft.com/office/drawing/2014/main" id="{44046C38-6129-559B-8717-02E1A5443B5C}"/>
              </a:ext>
            </a:extLst>
          </p:cNvPr>
          <p:cNvGrpSpPr/>
          <p:nvPr/>
        </p:nvGrpSpPr>
        <p:grpSpPr>
          <a:xfrm>
            <a:off x="3377781" y="5641193"/>
            <a:ext cx="3141217" cy="2160000"/>
            <a:chOff x="5284775" y="4872612"/>
            <a:chExt cx="3141217" cy="2160000"/>
          </a:xfrm>
        </p:grpSpPr>
        <p:sp>
          <p:nvSpPr>
            <p:cNvPr id="33" name="Rectangle 4">
              <a:extLst>
                <a:ext uri="{FF2B5EF4-FFF2-40B4-BE49-F238E27FC236}">
                  <a16:creationId xmlns:a16="http://schemas.microsoft.com/office/drawing/2014/main" id="{D9028844-B6D0-3A36-AFE5-D8A6B25CF1A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658506" y="5689381"/>
              <a:ext cx="1622425" cy="369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l-GR" altLang="pt-BR" sz="1800" b="1" dirty="0">
                  <a:latin typeface="Calibri" panose="020F0502020204030204" pitchFamily="34" charset="0"/>
                </a:rPr>
                <a:t>α</a:t>
              </a:r>
              <a:r>
                <a:rPr lang="pt-BR" altLang="pt-BR" sz="1800" b="1" dirty="0">
                  <a:latin typeface="Calibri" panose="020F0502020204030204" pitchFamily="34" charset="0"/>
                </a:rPr>
                <a:t>-</a:t>
              </a:r>
              <a:r>
                <a:rPr lang="pt-BR" altLang="pt-BR" sz="1800" b="1" dirty="0" err="1">
                  <a:latin typeface="Calibri" panose="020F0502020204030204" pitchFamily="34" charset="0"/>
                </a:rPr>
                <a:t>sin</a:t>
              </a:r>
              <a:r>
                <a:rPr lang="pt-BR" altLang="pt-BR" sz="1800" b="1" dirty="0">
                  <a:latin typeface="Calibri" panose="020F0502020204030204" pitchFamily="34" charset="0"/>
                </a:rPr>
                <a:t> A30P 24h</a:t>
              </a:r>
            </a:p>
          </p:txBody>
        </p:sp>
        <p:pic>
          <p:nvPicPr>
            <p:cNvPr id="36" name="Picture 9">
              <a:extLst>
                <a:ext uri="{FF2B5EF4-FFF2-40B4-BE49-F238E27FC236}">
                  <a16:creationId xmlns:a16="http://schemas.microsoft.com/office/drawing/2014/main" id="{924205D9-F677-4427-38A6-74986D5A3104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81636" y="4872612"/>
              <a:ext cx="2844356" cy="216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44" name="Agrupar 43">
            <a:extLst>
              <a:ext uri="{FF2B5EF4-FFF2-40B4-BE49-F238E27FC236}">
                <a16:creationId xmlns:a16="http://schemas.microsoft.com/office/drawing/2014/main" id="{1186F6EA-EDEC-DE81-F81E-9BCE7DB117ED}"/>
              </a:ext>
            </a:extLst>
          </p:cNvPr>
          <p:cNvGrpSpPr>
            <a:grpSpLocks noChangeAspect="1"/>
          </p:cNvGrpSpPr>
          <p:nvPr/>
        </p:nvGrpSpPr>
        <p:grpSpPr>
          <a:xfrm>
            <a:off x="292087" y="5670145"/>
            <a:ext cx="3120857" cy="2160000"/>
            <a:chOff x="1231886" y="4904362"/>
            <a:chExt cx="3120857" cy="2160000"/>
          </a:xfrm>
        </p:grpSpPr>
        <p:sp>
          <p:nvSpPr>
            <p:cNvPr id="32" name="Rectangle 3">
              <a:extLst>
                <a:ext uri="{FF2B5EF4-FFF2-40B4-BE49-F238E27FC236}">
                  <a16:creationId xmlns:a16="http://schemas.microsoft.com/office/drawing/2014/main" id="{55C043C8-1C3B-B2A8-0721-E31FB248933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3561" y="5739388"/>
              <a:ext cx="1506537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l-GR" altLang="pt-BR" sz="1800" b="1" dirty="0">
                  <a:latin typeface="Calibri" panose="020F0502020204030204" pitchFamily="34" charset="0"/>
                </a:rPr>
                <a:t>α</a:t>
              </a:r>
              <a:r>
                <a:rPr lang="pt-BR" altLang="pt-BR" sz="1800" b="1" dirty="0">
                  <a:latin typeface="Calibri" panose="020F0502020204030204" pitchFamily="34" charset="0"/>
                </a:rPr>
                <a:t>-</a:t>
              </a:r>
              <a:r>
                <a:rPr lang="pt-BR" altLang="pt-BR" sz="1800" b="1" dirty="0" err="1">
                  <a:latin typeface="Calibri" panose="020F0502020204030204" pitchFamily="34" charset="0"/>
                </a:rPr>
                <a:t>sin</a:t>
              </a:r>
              <a:r>
                <a:rPr lang="pt-BR" altLang="pt-BR" sz="1800" b="1" dirty="0">
                  <a:latin typeface="Calibri" panose="020F0502020204030204" pitchFamily="34" charset="0"/>
                </a:rPr>
                <a:t> A30P 0h</a:t>
              </a:r>
            </a:p>
          </p:txBody>
        </p:sp>
        <p:pic>
          <p:nvPicPr>
            <p:cNvPr id="37" name="Picture 10">
              <a:extLst>
                <a:ext uri="{FF2B5EF4-FFF2-40B4-BE49-F238E27FC236}">
                  <a16:creationId xmlns:a16="http://schemas.microsoft.com/office/drawing/2014/main" id="{A85BD255-92C4-1CEE-9BF1-05E11A3B185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679"/>
            <a:stretch>
              <a:fillRect/>
            </a:stretch>
          </p:blipFill>
          <p:spPr bwMode="auto">
            <a:xfrm>
              <a:off x="1522398" y="4904362"/>
              <a:ext cx="2830345" cy="216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42" name="TextBox 62">
            <a:extLst>
              <a:ext uri="{FF2B5EF4-FFF2-40B4-BE49-F238E27FC236}">
                <a16:creationId xmlns:a16="http://schemas.microsoft.com/office/drawing/2014/main" id="{D5515D22-47B6-BBED-06D5-2D551FD73E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34616" y="1566897"/>
            <a:ext cx="415498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B</a:t>
            </a:r>
          </a:p>
        </p:txBody>
      </p:sp>
      <p:sp>
        <p:nvSpPr>
          <p:cNvPr id="43" name="TextBox 62">
            <a:extLst>
              <a:ext uri="{FF2B5EF4-FFF2-40B4-BE49-F238E27FC236}">
                <a16:creationId xmlns:a16="http://schemas.microsoft.com/office/drawing/2014/main" id="{DCDF9F97-3C99-4657-BD8D-56264C51BB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08116" y="1566897"/>
            <a:ext cx="402674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C</a:t>
            </a:r>
          </a:p>
        </p:txBody>
      </p:sp>
      <p:sp>
        <p:nvSpPr>
          <p:cNvPr id="46" name="TextBox 62">
            <a:extLst>
              <a:ext uri="{FF2B5EF4-FFF2-40B4-BE49-F238E27FC236}">
                <a16:creationId xmlns:a16="http://schemas.microsoft.com/office/drawing/2014/main" id="{1DF22B87-C5E6-29DA-EA4E-2FE31EFDB7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016" y="5072097"/>
            <a:ext cx="442750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D</a:t>
            </a:r>
          </a:p>
        </p:txBody>
      </p:sp>
      <p:sp>
        <p:nvSpPr>
          <p:cNvPr id="47" name="TextBox 62">
            <a:extLst>
              <a:ext uri="{FF2B5EF4-FFF2-40B4-BE49-F238E27FC236}">
                <a16:creationId xmlns:a16="http://schemas.microsoft.com/office/drawing/2014/main" id="{1017F0F9-0B3C-8796-30F4-0EB3F5BAA4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47316" y="5072097"/>
            <a:ext cx="385042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E</a:t>
            </a:r>
          </a:p>
        </p:txBody>
      </p:sp>
      <p:sp>
        <p:nvSpPr>
          <p:cNvPr id="48" name="TextBox 62">
            <a:extLst>
              <a:ext uri="{FF2B5EF4-FFF2-40B4-BE49-F238E27FC236}">
                <a16:creationId xmlns:a16="http://schemas.microsoft.com/office/drawing/2014/main" id="{3D823251-DFDE-ACFB-62B4-83BB3F43AB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20816" y="5072097"/>
            <a:ext cx="373820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F</a:t>
            </a:r>
          </a:p>
        </p:txBody>
      </p:sp>
      <p:grpSp>
        <p:nvGrpSpPr>
          <p:cNvPr id="54" name="Agrupar 53">
            <a:extLst>
              <a:ext uri="{FF2B5EF4-FFF2-40B4-BE49-F238E27FC236}">
                <a16:creationId xmlns:a16="http://schemas.microsoft.com/office/drawing/2014/main" id="{F87214FD-CD57-87F5-3036-EC36F9BA8377}"/>
              </a:ext>
            </a:extLst>
          </p:cNvPr>
          <p:cNvGrpSpPr>
            <a:grpSpLocks noChangeAspect="1"/>
          </p:cNvGrpSpPr>
          <p:nvPr/>
        </p:nvGrpSpPr>
        <p:grpSpPr>
          <a:xfrm>
            <a:off x="1356279" y="8001291"/>
            <a:ext cx="5438221" cy="3009101"/>
            <a:chOff x="797479" y="6575108"/>
            <a:chExt cx="6506940" cy="3600450"/>
          </a:xfrm>
        </p:grpSpPr>
        <p:pic>
          <p:nvPicPr>
            <p:cNvPr id="40" name="Imagem 3">
              <a:extLst>
                <a:ext uri="{FF2B5EF4-FFF2-40B4-BE49-F238E27FC236}">
                  <a16:creationId xmlns:a16="http://schemas.microsoft.com/office/drawing/2014/main" id="{751E9E98-C241-3C37-949C-BC9B7424846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13" b="72334"/>
            <a:stretch/>
          </p:blipFill>
          <p:spPr bwMode="auto">
            <a:xfrm>
              <a:off x="797479" y="6575108"/>
              <a:ext cx="6506940" cy="3600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9" name="CaixaDeTexto 48">
              <a:extLst>
                <a:ext uri="{FF2B5EF4-FFF2-40B4-BE49-F238E27FC236}">
                  <a16:creationId xmlns:a16="http://schemas.microsoft.com/office/drawing/2014/main" id="{BD781417-EC3B-8666-8DC3-99D5DE20BEB2}"/>
                </a:ext>
              </a:extLst>
            </p:cNvPr>
            <p:cNvSpPr txBox="1"/>
            <p:nvPr/>
          </p:nvSpPr>
          <p:spPr>
            <a:xfrm>
              <a:off x="1348932" y="6679809"/>
              <a:ext cx="505267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pt-BR" sz="2400" b="1" dirty="0"/>
                <a:t>0h</a:t>
              </a:r>
            </a:p>
          </p:txBody>
        </p:sp>
        <p:sp>
          <p:nvSpPr>
            <p:cNvPr id="50" name="CaixaDeTexto 49">
              <a:extLst>
                <a:ext uri="{FF2B5EF4-FFF2-40B4-BE49-F238E27FC236}">
                  <a16:creationId xmlns:a16="http://schemas.microsoft.com/office/drawing/2014/main" id="{78E5BEC3-CA47-8838-A31D-0C725EBB4195}"/>
                </a:ext>
              </a:extLst>
            </p:cNvPr>
            <p:cNvSpPr txBox="1"/>
            <p:nvPr/>
          </p:nvSpPr>
          <p:spPr>
            <a:xfrm>
              <a:off x="2872932" y="6679809"/>
              <a:ext cx="660758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pt-BR" sz="2400" b="1" dirty="0"/>
                <a:t>24h</a:t>
              </a:r>
            </a:p>
          </p:txBody>
        </p:sp>
        <p:sp>
          <p:nvSpPr>
            <p:cNvPr id="51" name="CaixaDeTexto 50">
              <a:extLst>
                <a:ext uri="{FF2B5EF4-FFF2-40B4-BE49-F238E27FC236}">
                  <a16:creationId xmlns:a16="http://schemas.microsoft.com/office/drawing/2014/main" id="{92F7B8CB-B284-1ABA-1D4D-E2F934C46605}"/>
                </a:ext>
              </a:extLst>
            </p:cNvPr>
            <p:cNvSpPr txBox="1"/>
            <p:nvPr/>
          </p:nvSpPr>
          <p:spPr>
            <a:xfrm>
              <a:off x="4282632" y="6679809"/>
              <a:ext cx="660758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pt-BR" sz="2400" b="1" dirty="0"/>
                <a:t>48h</a:t>
              </a:r>
            </a:p>
          </p:txBody>
        </p:sp>
        <p:sp>
          <p:nvSpPr>
            <p:cNvPr id="52" name="CaixaDeTexto 51">
              <a:extLst>
                <a:ext uri="{FF2B5EF4-FFF2-40B4-BE49-F238E27FC236}">
                  <a16:creationId xmlns:a16="http://schemas.microsoft.com/office/drawing/2014/main" id="{7C33B639-C7E4-831D-5936-8C275373A073}"/>
                </a:ext>
              </a:extLst>
            </p:cNvPr>
            <p:cNvSpPr txBox="1"/>
            <p:nvPr/>
          </p:nvSpPr>
          <p:spPr>
            <a:xfrm>
              <a:off x="5501832" y="6679809"/>
              <a:ext cx="1143775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pt-BR" sz="2400" b="1" dirty="0"/>
                <a:t>10 </a:t>
              </a:r>
              <a:r>
                <a:rPr lang="pt-BR" sz="2400" b="1" dirty="0" err="1"/>
                <a:t>days</a:t>
              </a:r>
              <a:endParaRPr lang="pt-BR" sz="2400" b="1" dirty="0"/>
            </a:p>
          </p:txBody>
        </p:sp>
      </p:grpSp>
      <p:sp>
        <p:nvSpPr>
          <p:cNvPr id="53" name="CaixaDeTexto 52">
            <a:extLst>
              <a:ext uri="{FF2B5EF4-FFF2-40B4-BE49-F238E27FC236}">
                <a16:creationId xmlns:a16="http://schemas.microsoft.com/office/drawing/2014/main" id="{B34028C3-BA4F-E971-75BD-C9FA85AB90F8}"/>
              </a:ext>
            </a:extLst>
          </p:cNvPr>
          <p:cNvSpPr txBox="1"/>
          <p:nvPr/>
        </p:nvSpPr>
        <p:spPr>
          <a:xfrm>
            <a:off x="25733" y="9393923"/>
            <a:ext cx="12740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b="1" dirty="0"/>
              <a:t>A11</a:t>
            </a:r>
          </a:p>
          <a:p>
            <a:pPr algn="ctr"/>
            <a:r>
              <a:rPr lang="el-GR" b="1" dirty="0"/>
              <a:t>α</a:t>
            </a:r>
            <a:r>
              <a:rPr lang="pt-BR" b="1" dirty="0"/>
              <a:t>-</a:t>
            </a:r>
            <a:r>
              <a:rPr lang="pt-BR" b="1" dirty="0" err="1"/>
              <a:t>Oligomer</a:t>
            </a:r>
            <a:endParaRPr lang="pt-BR" b="1" dirty="0"/>
          </a:p>
        </p:txBody>
      </p:sp>
      <p:sp>
        <p:nvSpPr>
          <p:cNvPr id="55" name="CaixaDeTexto 54">
            <a:extLst>
              <a:ext uri="{FF2B5EF4-FFF2-40B4-BE49-F238E27FC236}">
                <a16:creationId xmlns:a16="http://schemas.microsoft.com/office/drawing/2014/main" id="{6F7C1241-0D14-4253-939C-C13A9584C905}"/>
              </a:ext>
            </a:extLst>
          </p:cNvPr>
          <p:cNvSpPr txBox="1"/>
          <p:nvPr/>
        </p:nvSpPr>
        <p:spPr>
          <a:xfrm>
            <a:off x="255514" y="10194023"/>
            <a:ext cx="8739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b="1" dirty="0"/>
              <a:t>OC</a:t>
            </a:r>
          </a:p>
          <a:p>
            <a:pPr algn="ctr"/>
            <a:r>
              <a:rPr lang="el-GR" b="1" dirty="0"/>
              <a:t>α</a:t>
            </a:r>
            <a:r>
              <a:rPr lang="pt-BR" b="1" dirty="0"/>
              <a:t>-</a:t>
            </a:r>
            <a:r>
              <a:rPr lang="pt-BR" b="1" dirty="0" err="1"/>
              <a:t>Fiber</a:t>
            </a:r>
            <a:endParaRPr lang="pt-BR" b="1" dirty="0"/>
          </a:p>
        </p:txBody>
      </p:sp>
      <p:sp>
        <p:nvSpPr>
          <p:cNvPr id="56" name="CaixaDeTexto 55">
            <a:extLst>
              <a:ext uri="{FF2B5EF4-FFF2-40B4-BE49-F238E27FC236}">
                <a16:creationId xmlns:a16="http://schemas.microsoft.com/office/drawing/2014/main" id="{3BD5DBF6-5902-729D-29AE-67C801F27770}"/>
              </a:ext>
            </a:extLst>
          </p:cNvPr>
          <p:cNvSpPr txBox="1"/>
          <p:nvPr/>
        </p:nvSpPr>
        <p:spPr>
          <a:xfrm>
            <a:off x="25195" y="8597211"/>
            <a:ext cx="13340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b="1" dirty="0"/>
              <a:t>α</a:t>
            </a:r>
            <a:r>
              <a:rPr lang="pt-BR" b="1" dirty="0"/>
              <a:t>-</a:t>
            </a:r>
            <a:r>
              <a:rPr lang="pt-BR" b="1" dirty="0" err="1"/>
              <a:t>syn</a:t>
            </a:r>
            <a:endParaRPr lang="pt-BR" b="1" dirty="0"/>
          </a:p>
          <a:p>
            <a:pPr algn="ctr"/>
            <a:r>
              <a:rPr lang="el-GR" b="1" dirty="0"/>
              <a:t>α</a:t>
            </a:r>
            <a:r>
              <a:rPr lang="pt-BR" b="1" dirty="0"/>
              <a:t>-</a:t>
            </a:r>
            <a:r>
              <a:rPr lang="pt-BR" b="1" dirty="0" err="1"/>
              <a:t>monomer</a:t>
            </a:r>
            <a:endParaRPr lang="pt-BR" b="1" dirty="0"/>
          </a:p>
        </p:txBody>
      </p:sp>
      <p:grpSp>
        <p:nvGrpSpPr>
          <p:cNvPr id="63" name="Agrupar 62">
            <a:extLst>
              <a:ext uri="{FF2B5EF4-FFF2-40B4-BE49-F238E27FC236}">
                <a16:creationId xmlns:a16="http://schemas.microsoft.com/office/drawing/2014/main" id="{3FA866BF-5893-6E11-39FA-472BB36609C1}"/>
              </a:ext>
            </a:extLst>
          </p:cNvPr>
          <p:cNvGrpSpPr/>
          <p:nvPr/>
        </p:nvGrpSpPr>
        <p:grpSpPr>
          <a:xfrm>
            <a:off x="6436094" y="8188689"/>
            <a:ext cx="2799808" cy="3009101"/>
            <a:chOff x="6486894" y="6813306"/>
            <a:chExt cx="2799808" cy="3009101"/>
          </a:xfrm>
        </p:grpSpPr>
        <p:pic>
          <p:nvPicPr>
            <p:cNvPr id="41" name="Imagem 40">
              <a:extLst>
                <a:ext uri="{FF2B5EF4-FFF2-40B4-BE49-F238E27FC236}">
                  <a16:creationId xmlns:a16="http://schemas.microsoft.com/office/drawing/2014/main" id="{A06D7DFC-6EAA-30BD-AF34-FD9C9DF5D604}"/>
                </a:ext>
              </a:extLst>
            </p:cNvPr>
            <p:cNvPicPr/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145" t="28854" r="28916" b="43946"/>
            <a:stretch/>
          </p:blipFill>
          <p:spPr>
            <a:xfrm>
              <a:off x="6486894" y="6813306"/>
              <a:ext cx="2799808" cy="3009101"/>
            </a:xfrm>
            <a:prstGeom prst="rect">
              <a:avLst/>
            </a:prstGeom>
          </p:spPr>
        </p:pic>
        <p:sp>
          <p:nvSpPr>
            <p:cNvPr id="58" name="CaixaDeTexto 57">
              <a:extLst>
                <a:ext uri="{FF2B5EF4-FFF2-40B4-BE49-F238E27FC236}">
                  <a16:creationId xmlns:a16="http://schemas.microsoft.com/office/drawing/2014/main" id="{5147F6F9-CFCF-2527-C175-A490F8F19A24}"/>
                </a:ext>
              </a:extLst>
            </p:cNvPr>
            <p:cNvSpPr txBox="1"/>
            <p:nvPr/>
          </p:nvSpPr>
          <p:spPr>
            <a:xfrm>
              <a:off x="7558744" y="9154505"/>
              <a:ext cx="492443" cy="360035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pt-BR" sz="2000" b="1" dirty="0"/>
                <a:t>0h</a:t>
              </a:r>
            </a:p>
          </p:txBody>
        </p:sp>
        <p:sp>
          <p:nvSpPr>
            <p:cNvPr id="59" name="CaixaDeTexto 58">
              <a:extLst>
                <a:ext uri="{FF2B5EF4-FFF2-40B4-BE49-F238E27FC236}">
                  <a16:creationId xmlns:a16="http://schemas.microsoft.com/office/drawing/2014/main" id="{4B882908-7D54-90B7-2AA0-9E088CD49572}"/>
                </a:ext>
              </a:extLst>
            </p:cNvPr>
            <p:cNvSpPr txBox="1"/>
            <p:nvPr/>
          </p:nvSpPr>
          <p:spPr>
            <a:xfrm>
              <a:off x="7927044" y="9138962"/>
              <a:ext cx="492443" cy="489878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pt-BR" sz="2000" b="1" dirty="0"/>
                <a:t>24h</a:t>
              </a:r>
            </a:p>
          </p:txBody>
        </p:sp>
        <p:sp>
          <p:nvSpPr>
            <p:cNvPr id="60" name="CaixaDeTexto 59">
              <a:extLst>
                <a:ext uri="{FF2B5EF4-FFF2-40B4-BE49-F238E27FC236}">
                  <a16:creationId xmlns:a16="http://schemas.microsoft.com/office/drawing/2014/main" id="{E8B2F53E-EEB8-A5AC-AE55-AD33E56E4B83}"/>
                </a:ext>
              </a:extLst>
            </p:cNvPr>
            <p:cNvSpPr txBox="1"/>
            <p:nvPr/>
          </p:nvSpPr>
          <p:spPr>
            <a:xfrm>
              <a:off x="8320744" y="9151662"/>
              <a:ext cx="492443" cy="489878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pt-BR" sz="2000" b="1" dirty="0"/>
                <a:t>48h</a:t>
              </a:r>
            </a:p>
          </p:txBody>
        </p:sp>
        <p:sp>
          <p:nvSpPr>
            <p:cNvPr id="61" name="CaixaDeTexto 60">
              <a:extLst>
                <a:ext uri="{FF2B5EF4-FFF2-40B4-BE49-F238E27FC236}">
                  <a16:creationId xmlns:a16="http://schemas.microsoft.com/office/drawing/2014/main" id="{2EB50E82-0802-3358-F495-BFD53E1CC5E5}"/>
                </a:ext>
              </a:extLst>
            </p:cNvPr>
            <p:cNvSpPr txBox="1"/>
            <p:nvPr/>
          </p:nvSpPr>
          <p:spPr>
            <a:xfrm>
              <a:off x="8701744" y="9164362"/>
              <a:ext cx="492443" cy="489878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pt-BR" sz="2000" b="1" dirty="0"/>
                <a:t>10d</a:t>
              </a:r>
            </a:p>
          </p:txBody>
        </p:sp>
        <p:sp>
          <p:nvSpPr>
            <p:cNvPr id="62" name="CaixaDeTexto 61">
              <a:extLst>
                <a:ext uri="{FF2B5EF4-FFF2-40B4-BE49-F238E27FC236}">
                  <a16:creationId xmlns:a16="http://schemas.microsoft.com/office/drawing/2014/main" id="{EAFE643A-73EF-F816-0133-8984EFD76E4D}"/>
                </a:ext>
              </a:extLst>
            </p:cNvPr>
            <p:cNvSpPr txBox="1"/>
            <p:nvPr/>
          </p:nvSpPr>
          <p:spPr>
            <a:xfrm>
              <a:off x="6514034" y="6978609"/>
              <a:ext cx="461665" cy="2261838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en-US" b="1" dirty="0" err="1"/>
                <a:t>ThT</a:t>
              </a:r>
              <a:r>
                <a:rPr lang="en-US" b="1" dirty="0"/>
                <a:t> fluorescence (</a:t>
              </a:r>
              <a:r>
                <a:rPr lang="en-US" b="1" dirty="0" err="1"/>
                <a:t>a.u</a:t>
              </a:r>
              <a:r>
                <a:rPr lang="en-US" b="1" dirty="0"/>
                <a:t>.)</a:t>
              </a:r>
            </a:p>
          </p:txBody>
        </p:sp>
      </p:grpSp>
      <p:sp>
        <p:nvSpPr>
          <p:cNvPr id="64" name="TextBox 62">
            <a:extLst>
              <a:ext uri="{FF2B5EF4-FFF2-40B4-BE49-F238E27FC236}">
                <a16:creationId xmlns:a16="http://schemas.microsoft.com/office/drawing/2014/main" id="{593B7FA6-F40E-5F91-C81E-0AA1176632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5716" y="7853397"/>
            <a:ext cx="442750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G</a:t>
            </a:r>
          </a:p>
        </p:txBody>
      </p:sp>
      <p:sp>
        <p:nvSpPr>
          <p:cNvPr id="65" name="TextBox 62">
            <a:extLst>
              <a:ext uri="{FF2B5EF4-FFF2-40B4-BE49-F238E27FC236}">
                <a16:creationId xmlns:a16="http://schemas.microsoft.com/office/drawing/2014/main" id="{B0F8EEAE-9640-974C-B21E-D6792C6A9D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30316" y="7853397"/>
            <a:ext cx="444352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H</a:t>
            </a:r>
          </a:p>
        </p:txBody>
      </p:sp>
      <p:sp>
        <p:nvSpPr>
          <p:cNvPr id="2" name="CaixaDeTexto 1">
            <a:extLst>
              <a:ext uri="{FF2B5EF4-FFF2-40B4-BE49-F238E27FC236}">
                <a16:creationId xmlns:a16="http://schemas.microsoft.com/office/drawing/2014/main" id="{BFCEBC2D-CF88-289F-D4F1-A649C8DAF512}"/>
              </a:ext>
            </a:extLst>
          </p:cNvPr>
          <p:cNvSpPr txBox="1"/>
          <p:nvPr/>
        </p:nvSpPr>
        <p:spPr>
          <a:xfrm>
            <a:off x="255514" y="369651"/>
            <a:ext cx="27861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lementary Figure 1:</a:t>
            </a:r>
          </a:p>
        </p:txBody>
      </p:sp>
    </p:spTree>
    <p:extLst>
      <p:ext uri="{BB962C8B-B14F-4D97-AF65-F5344CB8AC3E}">
        <p14:creationId xmlns:p14="http://schemas.microsoft.com/office/powerpoint/2010/main" val="3542879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a 5">
            <a:extLst>
              <a:ext uri="{FF2B5EF4-FFF2-40B4-BE49-F238E27FC236}">
                <a16:creationId xmlns:a16="http://schemas.microsoft.com/office/drawing/2014/main" id="{7E3D9EB9-540E-AB6C-34F0-E6A76B3856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1666863"/>
              </p:ext>
            </p:extLst>
          </p:nvPr>
        </p:nvGraphicFramePr>
        <p:xfrm>
          <a:off x="248092" y="1835888"/>
          <a:ext cx="9010800" cy="9645763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990000">
                  <a:extLst>
                    <a:ext uri="{9D8B030D-6E8A-4147-A177-3AD203B41FA5}">
                      <a16:colId xmlns:a16="http://schemas.microsoft.com/office/drawing/2014/main" val="3014103896"/>
                    </a:ext>
                  </a:extLst>
                </a:gridCol>
                <a:gridCol w="2656800">
                  <a:extLst>
                    <a:ext uri="{9D8B030D-6E8A-4147-A177-3AD203B41FA5}">
                      <a16:colId xmlns:a16="http://schemas.microsoft.com/office/drawing/2014/main" val="4045880467"/>
                    </a:ext>
                  </a:extLst>
                </a:gridCol>
                <a:gridCol w="1710000">
                  <a:extLst>
                    <a:ext uri="{9D8B030D-6E8A-4147-A177-3AD203B41FA5}">
                      <a16:colId xmlns:a16="http://schemas.microsoft.com/office/drawing/2014/main" val="828361511"/>
                    </a:ext>
                  </a:extLst>
                </a:gridCol>
                <a:gridCol w="1710000">
                  <a:extLst>
                    <a:ext uri="{9D8B030D-6E8A-4147-A177-3AD203B41FA5}">
                      <a16:colId xmlns:a16="http://schemas.microsoft.com/office/drawing/2014/main" val="1091641025"/>
                    </a:ext>
                  </a:extLst>
                </a:gridCol>
                <a:gridCol w="972000">
                  <a:extLst>
                    <a:ext uri="{9D8B030D-6E8A-4147-A177-3AD203B41FA5}">
                      <a16:colId xmlns:a16="http://schemas.microsoft.com/office/drawing/2014/main" val="1233448240"/>
                    </a:ext>
                  </a:extLst>
                </a:gridCol>
                <a:gridCol w="972000">
                  <a:extLst>
                    <a:ext uri="{9D8B030D-6E8A-4147-A177-3AD203B41FA5}">
                      <a16:colId xmlns:a16="http://schemas.microsoft.com/office/drawing/2014/main" val="3315069937"/>
                    </a:ext>
                  </a:extLst>
                </a:gridCol>
              </a:tblGrid>
              <a:tr h="1359295"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Gene </a:t>
                      </a:r>
                      <a:r>
                        <a:rPr lang="pt-BR" sz="1400" b="1" u="none" strike="noStrike" dirty="0" err="1">
                          <a:effectLst/>
                        </a:rPr>
                        <a:t>Abbreviation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Gene </a:t>
                      </a:r>
                      <a:r>
                        <a:rPr lang="pt-BR" sz="1400" b="1" u="none" strike="noStrike" dirty="0" err="1">
                          <a:effectLst/>
                        </a:rPr>
                        <a:t>Name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FORWARD PRIMER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REVERSE PRIMER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Up or Down regulation by α-syn-O (2-folds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VIVIT </a:t>
                      </a:r>
                      <a:r>
                        <a:rPr lang="pt-BR" sz="1400" b="1" u="none" strike="noStrike" dirty="0" err="1">
                          <a:effectLst/>
                        </a:rPr>
                        <a:t>restored</a:t>
                      </a:r>
                      <a:r>
                        <a:rPr lang="pt-BR" sz="1400" b="1" u="none" strike="noStrike" dirty="0">
                          <a:effectLst/>
                        </a:rPr>
                        <a:t> normal </a:t>
                      </a:r>
                      <a:r>
                        <a:rPr lang="pt-BR" sz="1400" b="1" u="none" strike="noStrike" dirty="0" err="1">
                          <a:effectLst/>
                        </a:rPr>
                        <a:t>phenotype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extLst>
                  <a:ext uri="{0D108BD9-81ED-4DB2-BD59-A6C34878D82A}">
                    <a16:rowId xmlns:a16="http://schemas.microsoft.com/office/drawing/2014/main" val="2469554907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Actr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ARP2 actin-related protein 2 homolog (yeast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TCTCTGTCCCTTTTGA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AAGAAAGCAAAAATTG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869902727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Actr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RP3 actin-related protein 3 homolog (yeast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CCGAGATCTTTTTCCA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TCCCTGAACATGGTTG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51617848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Ar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activity regulated cytoskeletal-associated protei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GGAGAATGACACCAGG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GGCACCTCCTCTCTGT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330195105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Arhgef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ho/rac guanine nucleotide exchange factor (GEF) 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CCTGTAACAAGAGCA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AGGGAGACAGACTGCA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4178039982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Arhgef25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ho guanine nucleotide exchange factor (GEF) 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AGGGAAAACTGACTGC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TCACCTTGATGCTGTT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968067464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Arhgef6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ac/Cdc42 guanine nucleotide exchange factor (GEF) 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GAGCTTTGTGCTTTGTG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AAAGGGCTGTTGGGCA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4005500697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ad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CL2-associated agonist of cell deat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TCTTTCGAGGCCTTAG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CCAGTTATGACAGGAC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533023484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ax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-associated X protei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AGCAAACTGGTGCTCAAG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TGGTCACTGTCTGCCAT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159563247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bc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 binding component 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GGGTCTGTGAAGAGCA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AGAGCACAGGATTCAC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UP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873566013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 cell leukemia/lymphoma 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ACTTCTCTCGTCGCTAC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ACTCAAAGAAGGCCAC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034422001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A1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 cell leukemia/lymphoma 2 related protein A1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AACTGGGGAAGGATTGT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CAGATCTGTCCTGTCA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OW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YES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260157104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L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-like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TCCCAGCTTCACATAAC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AATCCGACTCACCAAT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UP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YES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90544291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L10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-like 10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TTGCAACAGCCATCTT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TCACAAACCCAGAACTC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211596194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L1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-like 11 (apoptosis facilitator)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GTTAGGGGCTGGCTCT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CCAAGAAAGAGCACC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359349068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L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-like 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GGAACCAGGGTCAGGT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TGGTTTTCCCTGACAG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606542867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6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 cell leukemia/lymphoma 6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CTGAGGGAAGGCAATA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CTGTTCAGGAACTCT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613000511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dnf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rain derived neurotrophic factor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TGCAGAAAAGCAACAA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ACAAAAAGTTCCCAGA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61087068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id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H3 interacting domain death agonis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TGCTACGGAATGCAAA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ACCCAGGGAAAGAGGA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483443044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ik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-interacting killer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GGGTCTGTGAAGAGCA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AGAGCACAGGATTCAC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6349358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irc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aculoviral IAP repeat-containing 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CTTGCTGTATGTCCT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TGCACGCCTTTAAAAG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714371029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irc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aculoviral IAP repeat-containing 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TCCAACATTTGACGTG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TGCTGCAGTGTTTCCT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043316402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irc5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aculoviral IAP repeat-containing 5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TTTTGTGGCTTTGCTC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GCATTAGCAGCCCTGTA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53037093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mf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 modifying factor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GGCTTCTGGTATGTGC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CAAACTCTGGGCTCAGT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849928089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mp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one morphogenetic protein 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GCACACTTGCTGTCTG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TCTCACGGATTGGACA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097517580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mp4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one morphogenetic protein 4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AGAGCTCTGCTTTTCG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GTGTCCAGTAGTCGTG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OW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472238290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alm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almodulin 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AGCAGAACTGCAGGACA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AACTTCTCGCCAAGGTT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551441189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alm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almodulin 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CAGCTGACTGAGGAAC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CATCATGGTCAAGAAC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40183023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cl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hemokine (C-C motif) ligand 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TTTTTGTCACCAAGC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GTCAACTTCACATTCA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877238631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dh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adherin 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ATGTGATGACGGTCACTG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AAGGCCATAAGTGGGA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833649428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dkn1B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yclin-dependent kinase inhibitor 1B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CGTTTCTTCATTGCCT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CAAAACATGCCACTTTG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93427775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fl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ofilin 1, non-muscle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CTCCTACTAAACGGAAG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CCTCACTCAGGCAAAA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740833952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reb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AMP responsive element binding protein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AGCTGTGACTTGGCAT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GTTCTGTTTGGGACCT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976276018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st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estri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AGTCCAGGAAAGAAGAG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ACACAGGGGATCCTTCA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532377322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Egr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early growth response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AGCAGTCCCATCTACTC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CCCTGTTGTTGTGGAA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049334196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Fasl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as ligand (TNF superfamily, member 6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TGGAGTGGTCCTTAATG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AGTAGACCCACCCTGGA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4105226322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Fgf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fibroblast growth factor 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TGCTGGCTTCTAAGTG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ATGGCCTTCTGTCCAG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308286035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Gria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glutamate receptor, ionotropic, AMPA1 (alpha 1)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TAAAGGGGAATGTGGAAG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TACGGGATTTGTAGCA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041594659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Gria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glutamate receptor, ionotropic, AMPA2 (alpha 2)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GCGAAAGGGATAAAG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GTGTGCTCCAGGGTAT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152810719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Grin2B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glutamate receptor, ionotropic, NMDA2B (epsilon 2)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GCAGCACTATTGAGAA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TCCATGTGTAGCCGTAGC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374271344"/>
                  </a:ext>
                </a:extLst>
              </a:tr>
              <a:tr h="32814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Hrk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arakiri, BCL2 interacting protein (contains only BH3 domain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GCTCTGGGAAGTCTGT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AAAAGAGCACAAGGCA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789862109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Il1B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interleukin 1 be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CAACTGGTACATCAGC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CTGCTCATTCACGAAAAG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827173584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Il6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interleukin 6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ACCCCAATTTCCAATG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CACAGTGAGGAATGTC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436820908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Itpr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inositol 1,4,5-trisphosphate receptor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AACTCCTGGAGAAGCA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AACGCCTTCAAACTCA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823101113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Kalr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Kalirin, RhoGEF kinase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TCATACAGGAGGGCAC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CTTCAGGAAGGACTTAG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UP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YES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135613300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Map2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Microtubule-associated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protein</a:t>
                      </a:r>
                      <a:r>
                        <a:rPr lang="pt-BR" sz="1000" u="none" strike="noStrike" dirty="0">
                          <a:effectLst/>
                        </a:rPr>
                        <a:t> 2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CCTTCTTTCCCTCGTTTCT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CTTGCCAGCAGTCACAATA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281428052"/>
                  </a:ext>
                </a:extLst>
              </a:tr>
            </a:tbl>
          </a:graphicData>
        </a:graphic>
      </p:graphicFrame>
      <p:sp>
        <p:nvSpPr>
          <p:cNvPr id="2" name="CaixaDeTexto 1">
            <a:extLst>
              <a:ext uri="{FF2B5EF4-FFF2-40B4-BE49-F238E27FC236}">
                <a16:creationId xmlns:a16="http://schemas.microsoft.com/office/drawing/2014/main" id="{E447F427-6343-52FD-E9F5-8E0B5495682C}"/>
              </a:ext>
            </a:extLst>
          </p:cNvPr>
          <p:cNvSpPr txBox="1"/>
          <p:nvPr/>
        </p:nvSpPr>
        <p:spPr>
          <a:xfrm>
            <a:off x="255514" y="369651"/>
            <a:ext cx="26926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lementary Table 1:</a:t>
            </a:r>
          </a:p>
        </p:txBody>
      </p:sp>
    </p:spTree>
    <p:extLst>
      <p:ext uri="{BB962C8B-B14F-4D97-AF65-F5344CB8AC3E}">
        <p14:creationId xmlns:p14="http://schemas.microsoft.com/office/powerpoint/2010/main" val="35905621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ela 6">
            <a:extLst>
              <a:ext uri="{FF2B5EF4-FFF2-40B4-BE49-F238E27FC236}">
                <a16:creationId xmlns:a16="http://schemas.microsoft.com/office/drawing/2014/main" id="{ACF30C1B-00FD-58AF-313E-4513B5C154B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0752798"/>
              </p:ext>
            </p:extLst>
          </p:nvPr>
        </p:nvGraphicFramePr>
        <p:xfrm>
          <a:off x="170122" y="1070348"/>
          <a:ext cx="9005720" cy="10098056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988541">
                  <a:extLst>
                    <a:ext uri="{9D8B030D-6E8A-4147-A177-3AD203B41FA5}">
                      <a16:colId xmlns:a16="http://schemas.microsoft.com/office/drawing/2014/main" val="1170602937"/>
                    </a:ext>
                  </a:extLst>
                </a:gridCol>
                <a:gridCol w="2654881">
                  <a:extLst>
                    <a:ext uri="{9D8B030D-6E8A-4147-A177-3AD203B41FA5}">
                      <a16:colId xmlns:a16="http://schemas.microsoft.com/office/drawing/2014/main" val="1935969309"/>
                    </a:ext>
                  </a:extLst>
                </a:gridCol>
                <a:gridCol w="1708298">
                  <a:extLst>
                    <a:ext uri="{9D8B030D-6E8A-4147-A177-3AD203B41FA5}">
                      <a16:colId xmlns:a16="http://schemas.microsoft.com/office/drawing/2014/main" val="3174978292"/>
                    </a:ext>
                  </a:extLst>
                </a:gridCol>
                <a:gridCol w="1710000">
                  <a:extLst>
                    <a:ext uri="{9D8B030D-6E8A-4147-A177-3AD203B41FA5}">
                      <a16:colId xmlns:a16="http://schemas.microsoft.com/office/drawing/2014/main" val="351668507"/>
                    </a:ext>
                  </a:extLst>
                </a:gridCol>
                <a:gridCol w="972000">
                  <a:extLst>
                    <a:ext uri="{9D8B030D-6E8A-4147-A177-3AD203B41FA5}">
                      <a16:colId xmlns:a16="http://schemas.microsoft.com/office/drawing/2014/main" val="3969231845"/>
                    </a:ext>
                  </a:extLst>
                </a:gridCol>
                <a:gridCol w="972000">
                  <a:extLst>
                    <a:ext uri="{9D8B030D-6E8A-4147-A177-3AD203B41FA5}">
                      <a16:colId xmlns:a16="http://schemas.microsoft.com/office/drawing/2014/main" val="1547073410"/>
                    </a:ext>
                  </a:extLst>
                </a:gridCol>
              </a:tblGrid>
              <a:tr h="1366782"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Gene </a:t>
                      </a:r>
                      <a:r>
                        <a:rPr lang="pt-BR" sz="1400" b="1" u="none" strike="noStrike" dirty="0" err="1">
                          <a:effectLst/>
                        </a:rPr>
                        <a:t>Abbreviation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Gene </a:t>
                      </a:r>
                      <a:r>
                        <a:rPr lang="pt-BR" sz="1400" b="1" u="none" strike="noStrike" dirty="0" err="1">
                          <a:effectLst/>
                        </a:rPr>
                        <a:t>Name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FORWARD PRIMER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REVERSE PRIMER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Up or Down regulation by α-syn-O (2-folds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VIVIT </a:t>
                      </a:r>
                      <a:r>
                        <a:rPr lang="pt-BR" sz="1400" b="1" u="none" strike="noStrike" dirty="0" err="1">
                          <a:effectLst/>
                        </a:rPr>
                        <a:t>restored</a:t>
                      </a:r>
                      <a:r>
                        <a:rPr lang="pt-BR" sz="1400" b="1" u="none" strike="noStrike" dirty="0">
                          <a:effectLst/>
                        </a:rPr>
                        <a:t> normal </a:t>
                      </a:r>
                      <a:r>
                        <a:rPr lang="pt-BR" sz="1400" b="1" u="none" strike="noStrike" dirty="0" err="1">
                          <a:effectLst/>
                        </a:rPr>
                        <a:t>phenotype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extLst>
                  <a:ext uri="{0D108BD9-81ED-4DB2-BD59-A6C34878D82A}">
                    <a16:rowId xmlns:a16="http://schemas.microsoft.com/office/drawing/2014/main" val="1429557080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Map2K4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mitogen-activated protein kinase kinase 4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AAGAGGCAGTCTGTTG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GCTTCTTTTCGTTTTG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OW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980529473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Mcl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yeloid cell leukemia sequence 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GGACTCTTAAAGCTCC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TGCTGAGAGGGAACTT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UP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443154486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Myh10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yosin, heavy polypeptide 10, non-muscl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GACTTGAGTGAGGAGC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TTTGAACCTTTTCGCT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928821829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Myo6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myosin VI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GCTGCACTAGATTCTTC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TTTCCAAGGTGCAGGAC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407033614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eurog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eurogenin 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GTGGGAATTTCACCTG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AAATTTCCACGCTTGCA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391190985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gf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erve growth factor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AGCTCACCTCAGTGTCTG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TAGTCCAGTGGGCTTC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OW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217996437"/>
                  </a:ext>
                </a:extLst>
              </a:tr>
              <a:tr h="329885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gfr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erve growth factor receptor (TNFR superfamily, member 16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AAGCTGCTCAATGGTG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ATGTCAGCTCTCTGGATG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398999303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lgn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euroligin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TCTCCCTGGTCTGACA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GTAAGGGGACCATCT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449057330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s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itric oxide synthase 1, neuronal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ACACACCTGGAGACCAC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CCTGGGACCCTGTCTA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724239721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s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itric oxide synthase 2, inducibl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TTGTGCGAAGTGTCAG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CCTGGAACAGCACTCT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OW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619851824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r4A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uclear receptor subfamily 4, group A, member 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AAAGCGCCAAGTACATC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CTTGGGTTTTGAAGGT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723754631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rg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euregulin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TGGTGAAGGACCTGTCA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CTTGGTTTTGCAGTAGG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898951293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rg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eurograni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GCCCAAATACTCTCAAA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GCAGGTATGGGATAGG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875880984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ak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21 protein (Cdc42/Rac)-activated kinase 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GAGGTGGCCATTAAAC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TCCAGCCAAGTATTCCA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061189176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ak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21 protein (Cdc42/Rac)-activated kinase 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TTTGTGGCTTGAGGAA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TGGCTTGTCAAAGGCT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048949352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ak6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21 protein (Cdc42/Rac)-activated kinase 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CCACAGAGAGCCTCAG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CCCAGCATGTGTTAGA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973225978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ak7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21 protein (Cdc42/Rac)-activated kinase 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TCAAGAACTCCTTGGA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GTTTCCTCATGTTCTC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44304218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fn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rofilin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GAAGACCTTCGTTAGCA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TCAGCAGGACTAGCGT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167111601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maip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horbol-12-myristate-13-acetate-induced protein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TCGTGGAGCTAGGGAA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ATTGCTCTGCAGTTG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OW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998545577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ml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romyelocytic leukemi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AAAGAAGGTGTGGCCTC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GCTGGTATAGCGGTCA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221337970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te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hosphatase and tensin homolo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AAAGGATCTCCTCCCA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GCGTTCTGCCTAATCT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465379050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Rab3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AB3A, member RAS oncogene family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GAAGGAGTCCTCAGAC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CTTGTCGTTGCGGTAGA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82876612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Rgs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egulator of G-protein signaling 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GGTTGGCTTGTGAAGA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ACCCTCTTCTGAGCTG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415304845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Rheb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Ras homolog enriched in brai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AGATGCCTCAGTCCAA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GCTGTGTCTACAAGCTG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697644844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Rock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ho-associated coiled-coil containing protein kinase 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AAAGCAAGTCAGACC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TCTGCTTGTGACTTGG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508772097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nap25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aptosomal-associated protein 25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GGCTCTGAATCTCTCC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TGCGTAGTTGTTGCTT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140151957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n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uclein, alph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ATTGGGGAAAACAGGA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ACTGTTGTCACTCCAT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4015301496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ncaip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uclein, alpha interacting protein (synphilin)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GAAGCCACTCAGTCCA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TTTGTTCTCCGGATTC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551376921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ncb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uclein, be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CTACCTTTTCCCCCAA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TACATCCGAGCAGACA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927437825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rf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erum response factor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AGATAGAGCCTGGGCAA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GGATATACCACACGCA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958909546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apsin I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TGCTCAGCAGCACAACA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CCAGTTACCCGACACTGA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OW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YES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16204289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apsin II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CCTCTGTTCCTTTGTGC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GCCAGGAGTCCTACGT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915671732"/>
                  </a:ext>
                </a:extLst>
              </a:tr>
              <a:tr h="329885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gap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aptic Ras GTPase activating protein 1 homolog (rat)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ATGCACCGAACCCAAT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CAAGTGGTATTCATGC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912826148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j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aptojanin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GGAAGTTTGCGTGTTT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CTGTGAGCGTCTGGTT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998639014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po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aptopodin 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ACAAGATGGAAATGTTG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CCCATCTGGAAGGAAC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149321361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p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aptophysi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AGTGGGTCGATGTGAC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GGCTGACTGGTCCTCT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998354733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t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aptotagmin I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TCCAACCCCTACGTCA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TTCCCAATCACACAGTG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82538578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h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yrosine hydroxylase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TCAGAAGAGCCGTCTC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ATACCACAGCCTCCAA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113308877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nf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umor necrosis factor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CACTCTGACCCCTTTA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TGAGTCCTTGATGGTG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406053535"/>
                  </a:ext>
                </a:extLst>
              </a:tr>
              <a:tr h="329885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nfrsf2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umor necrosis factor receptor superfamily, member 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ACCACAGACACATTCT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GAGCTCTTTCGGATAC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182328806"/>
                  </a:ext>
                </a:extLst>
              </a:tr>
              <a:tr h="329885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nfsf10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umor necrosis factor (ligand) superfamily, member 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TTGGGAAGTCAGACCTG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CATCCGTCTTTGAGAAG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701609150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rp5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ransformation related protein 5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CTTTGAGGTTCGTGTT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AACATCTCGAAGCGTT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4120043765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ubb4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ubulin beta 4A class IV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GCCTCCAAGTCCTCTC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CCTCGTCCTTCAGCAC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OW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YES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757535732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Vamp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vesicle-associated membrane protein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ATGTCTGCTCCAGCTCA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AAGACCTTGTCCACAT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999195011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Vamp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vesicle-associated membrane protein 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AGGTTCCCATCACCTC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GTGGGGTTTGCTTTTG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838779355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Xiap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X-</a:t>
                      </a:r>
                      <a:r>
                        <a:rPr lang="pt-BR" sz="1000" u="none" strike="noStrike" dirty="0" err="1">
                          <a:effectLst/>
                        </a:rPr>
                        <a:t>linked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inhibitor</a:t>
                      </a:r>
                      <a:r>
                        <a:rPr lang="pt-BR" sz="1000" u="none" strike="noStrike" dirty="0">
                          <a:effectLst/>
                        </a:rPr>
                        <a:t> of </a:t>
                      </a:r>
                      <a:r>
                        <a:rPr lang="pt-BR" sz="1000" u="none" strike="noStrike" dirty="0" err="1">
                          <a:effectLst/>
                        </a:rPr>
                        <a:t>apoptosis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GTGGACATCTGGTCACTTG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CTTAAAGTTCGCTCCCATCA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DOWN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NO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4327172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215065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a 3">
            <a:extLst>
              <a:ext uri="{FF2B5EF4-FFF2-40B4-BE49-F238E27FC236}">
                <a16:creationId xmlns:a16="http://schemas.microsoft.com/office/drawing/2014/main" id="{F58BAB07-0E30-02E7-C190-1FE7A26AEA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1273316"/>
              </p:ext>
            </p:extLst>
          </p:nvPr>
        </p:nvGraphicFramePr>
        <p:xfrm>
          <a:off x="235098" y="831666"/>
          <a:ext cx="8823842" cy="1805206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601626">
                  <a:extLst>
                    <a:ext uri="{9D8B030D-6E8A-4147-A177-3AD203B41FA5}">
                      <a16:colId xmlns:a16="http://schemas.microsoft.com/office/drawing/2014/main" val="4058851932"/>
                    </a:ext>
                  </a:extLst>
                </a:gridCol>
                <a:gridCol w="1002710">
                  <a:extLst>
                    <a:ext uri="{9D8B030D-6E8A-4147-A177-3AD203B41FA5}">
                      <a16:colId xmlns:a16="http://schemas.microsoft.com/office/drawing/2014/main" val="659115201"/>
                    </a:ext>
                  </a:extLst>
                </a:gridCol>
                <a:gridCol w="3572152">
                  <a:extLst>
                    <a:ext uri="{9D8B030D-6E8A-4147-A177-3AD203B41FA5}">
                      <a16:colId xmlns:a16="http://schemas.microsoft.com/office/drawing/2014/main" val="1351255742"/>
                    </a:ext>
                  </a:extLst>
                </a:gridCol>
                <a:gridCol w="1867546">
                  <a:extLst>
                    <a:ext uri="{9D8B030D-6E8A-4147-A177-3AD203B41FA5}">
                      <a16:colId xmlns:a16="http://schemas.microsoft.com/office/drawing/2014/main" val="3497777410"/>
                    </a:ext>
                  </a:extLst>
                </a:gridCol>
                <a:gridCol w="1779808">
                  <a:extLst>
                    <a:ext uri="{9D8B030D-6E8A-4147-A177-3AD203B41FA5}">
                      <a16:colId xmlns:a16="http://schemas.microsoft.com/office/drawing/2014/main" val="1088816904"/>
                    </a:ext>
                  </a:extLst>
                </a:gridCol>
              </a:tblGrid>
              <a:tr h="535516">
                <a:tc>
                  <a:txBody>
                    <a:bodyPr/>
                    <a:lstStyle/>
                    <a:p>
                      <a:pPr algn="l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Gene </a:t>
                      </a:r>
                      <a:r>
                        <a:rPr lang="pt-BR" sz="1400" b="1" u="none" strike="noStrike" dirty="0" err="1">
                          <a:effectLst/>
                        </a:rPr>
                        <a:t>Abbreviation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Gene </a:t>
                      </a:r>
                      <a:r>
                        <a:rPr lang="pt-BR" sz="1400" b="1" u="none" strike="noStrike" dirty="0" err="1">
                          <a:effectLst/>
                        </a:rPr>
                        <a:t>Name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FORWARD PRIMER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REVERSE PRIMER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extLst>
                  <a:ext uri="{0D108BD9-81ED-4DB2-BD59-A6C34878D82A}">
                    <a16:rowId xmlns:a16="http://schemas.microsoft.com/office/drawing/2014/main" val="3577795510"/>
                  </a:ext>
                </a:extLst>
              </a:tr>
              <a:tr h="250483"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Mvpa1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Genomic DN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AGCCCAGTGTAGAAGAGCA 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 AGCCAGCGAACCATATCCTGA 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extLst>
                  <a:ext uri="{0D108BD9-81ED-4DB2-BD59-A6C34878D82A}">
                    <a16:rowId xmlns:a16="http://schemas.microsoft.com/office/drawing/2014/main" val="4213274765"/>
                  </a:ext>
                </a:extLst>
              </a:tr>
              <a:tr h="267758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 err="1">
                          <a:effectLst/>
                        </a:rPr>
                        <a:t>Constitutive</a:t>
                      </a:r>
                      <a:r>
                        <a:rPr lang="pt-BR" sz="1400" b="1" u="none" strike="noStrike" dirty="0">
                          <a:effectLst/>
                        </a:rPr>
                        <a:t> Genes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100" u="none" strike="noStrike" dirty="0" err="1">
                          <a:effectLst/>
                        </a:rPr>
                        <a:t>Ubc</a:t>
                      </a:r>
                      <a:endParaRPr lang="pt-B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ubiquitin 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ACAAAGCCCCTCAATC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CCTCCTTGTCCTGGATCTTT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extLst>
                  <a:ext uri="{0D108BD9-81ED-4DB2-BD59-A6C34878D82A}">
                    <a16:rowId xmlns:a16="http://schemas.microsoft.com/office/drawing/2014/main" val="2640904139"/>
                  </a:ext>
                </a:extLst>
              </a:tr>
              <a:tr h="250483"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Gapdh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Glyceraldehyde-3-phosphate dehydrogenase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GGAGAAACCTGCCAAG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GTTGCTGTAGCCGTATTCA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extLst>
                  <a:ext uri="{0D108BD9-81ED-4DB2-BD59-A6C34878D82A}">
                    <a16:rowId xmlns:a16="http://schemas.microsoft.com/office/drawing/2014/main" val="3913268552"/>
                  </a:ext>
                </a:extLst>
              </a:tr>
              <a:tr h="250483"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gk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hosphoglycerate kinase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AGATTGTTTGGAATGG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GCTCACATGGCTGACTTTA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extLst>
                  <a:ext uri="{0D108BD9-81ED-4DB2-BD59-A6C34878D82A}">
                    <a16:rowId xmlns:a16="http://schemas.microsoft.com/office/drawing/2014/main" val="1927232819"/>
                  </a:ext>
                </a:extLst>
              </a:tr>
              <a:tr h="250483"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Hprt1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Hypoxanthine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phosphoribosyltransferase</a:t>
                      </a:r>
                      <a:r>
                        <a:rPr lang="pt-BR" sz="1000" u="none" strike="noStrike" dirty="0">
                          <a:effectLst/>
                        </a:rPr>
                        <a:t> 1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GCTGACCTGCTGGATTACAT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TGGGGCTGTACTGCTTA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extLst>
                  <a:ext uri="{0D108BD9-81ED-4DB2-BD59-A6C34878D82A}">
                    <a16:rowId xmlns:a16="http://schemas.microsoft.com/office/drawing/2014/main" val="296208898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559638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a 1">
            <a:extLst>
              <a:ext uri="{FF2B5EF4-FFF2-40B4-BE49-F238E27FC236}">
                <a16:creationId xmlns:a16="http://schemas.microsoft.com/office/drawing/2014/main" id="{D5EB38B5-953A-F6DC-A625-2B00BFD328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8813914"/>
              </p:ext>
            </p:extLst>
          </p:nvPr>
        </p:nvGraphicFramePr>
        <p:xfrm>
          <a:off x="841951" y="1702953"/>
          <a:ext cx="7464318" cy="664228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24128">
                  <a:extLst>
                    <a:ext uri="{9D8B030D-6E8A-4147-A177-3AD203B41FA5}">
                      <a16:colId xmlns:a16="http://schemas.microsoft.com/office/drawing/2014/main" val="1500553657"/>
                    </a:ext>
                  </a:extLst>
                </a:gridCol>
                <a:gridCol w="1201381">
                  <a:extLst>
                    <a:ext uri="{9D8B030D-6E8A-4147-A177-3AD203B41FA5}">
                      <a16:colId xmlns:a16="http://schemas.microsoft.com/office/drawing/2014/main" val="169483836"/>
                    </a:ext>
                  </a:extLst>
                </a:gridCol>
                <a:gridCol w="2161480">
                  <a:extLst>
                    <a:ext uri="{9D8B030D-6E8A-4147-A177-3AD203B41FA5}">
                      <a16:colId xmlns:a16="http://schemas.microsoft.com/office/drawing/2014/main" val="390102929"/>
                    </a:ext>
                  </a:extLst>
                </a:gridCol>
                <a:gridCol w="846582">
                  <a:extLst>
                    <a:ext uri="{9D8B030D-6E8A-4147-A177-3AD203B41FA5}">
                      <a16:colId xmlns:a16="http://schemas.microsoft.com/office/drawing/2014/main" val="3672754369"/>
                    </a:ext>
                  </a:extLst>
                </a:gridCol>
                <a:gridCol w="2230747">
                  <a:extLst>
                    <a:ext uri="{9D8B030D-6E8A-4147-A177-3AD203B41FA5}">
                      <a16:colId xmlns:a16="http://schemas.microsoft.com/office/drawing/2014/main" val="3332514154"/>
                    </a:ext>
                  </a:extLst>
                </a:gridCol>
              </a:tblGrid>
              <a:tr h="1082801">
                <a:tc>
                  <a:txBody>
                    <a:bodyPr/>
                    <a:lstStyle/>
                    <a:p>
                      <a:pPr algn="l" fontAlgn="b"/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300" b="1" u="none" strike="noStrike" dirty="0">
                          <a:effectLst/>
                        </a:rPr>
                        <a:t># Conserved NFAT Biding Sites</a:t>
                      </a:r>
                      <a:r>
                        <a:rPr lang="en-US" sz="23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er Species</a:t>
                      </a: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23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7370375"/>
                  </a:ext>
                </a:extLst>
              </a:tr>
              <a:tr h="15164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300" u="none" strike="noStrike" dirty="0">
                          <a:effectLst/>
                        </a:rPr>
                        <a:t> </a:t>
                      </a:r>
                      <a:endParaRPr lang="en-US" sz="23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3100" b="1" u="none" strike="noStrike" dirty="0">
                          <a:effectLst/>
                        </a:rPr>
                        <a:t>GENES</a:t>
                      </a:r>
                      <a:endParaRPr lang="en-US" sz="3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300" b="1" u="none" strike="noStrike" dirty="0">
                          <a:effectLst/>
                        </a:rPr>
                        <a:t>Homo X Mus X Chimp X </a:t>
                      </a:r>
                      <a:r>
                        <a:rPr lang="en-US" sz="2300" b="1" u="none" strike="noStrike" dirty="0" err="1">
                          <a:effectLst/>
                        </a:rPr>
                        <a:t>Rhes</a:t>
                      </a:r>
                      <a:r>
                        <a:rPr lang="en-US" sz="2300" b="1" u="none" strike="noStrike" dirty="0">
                          <a:effectLst/>
                        </a:rPr>
                        <a:t> X Rat</a:t>
                      </a:r>
                      <a:endParaRPr lang="en-US" sz="23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300" b="1" u="none" strike="noStrike" dirty="0">
                          <a:effectLst/>
                        </a:rPr>
                        <a:t>Homo X Mus</a:t>
                      </a:r>
                      <a:endParaRPr lang="en-US" sz="23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3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mosome / Promoter Region in Human Genome</a:t>
                      </a: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4771537"/>
                  </a:ext>
                </a:extLst>
              </a:tr>
              <a:tr h="17725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NFAT Responsive </a:t>
                      </a:r>
                    </a:p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Gene (3000pb)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vert="vert27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Syn1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2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2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X:47479256-47482256</a:t>
                      </a:r>
                    </a:p>
                  </a:txBody>
                  <a:tcPr marL="12309" marR="12309" marT="12309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6716308"/>
                  </a:ext>
                </a:extLst>
              </a:tr>
              <a:tr h="75681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 NFAT Non- Responsive (6000pb)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vert="vert27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 err="1">
                          <a:effectLst/>
                        </a:rPr>
                        <a:t>Xiap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0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0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X:122987662-122993662</a:t>
                      </a:r>
                    </a:p>
                  </a:txBody>
                  <a:tcPr marL="12309" marR="12309" marT="1230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1819776"/>
                  </a:ext>
                </a:extLst>
              </a:tr>
              <a:tr h="756818">
                <a:tc vMerge="1">
                  <a:txBody>
                    <a:bodyPr/>
                    <a:lstStyle/>
                    <a:p>
                      <a:pPr algn="ctr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Pmaip1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0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0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18:57561192-57567192</a:t>
                      </a:r>
                    </a:p>
                  </a:txBody>
                  <a:tcPr marL="12309" marR="12309" marT="1230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9215983"/>
                  </a:ext>
                </a:extLst>
              </a:tr>
              <a:tr h="756818">
                <a:tc vMerge="1">
                  <a:txBody>
                    <a:bodyPr/>
                    <a:lstStyle/>
                    <a:p>
                      <a:pPr algn="ctr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Map2k4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0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0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17:11918135-11924035</a:t>
                      </a:r>
                    </a:p>
                  </a:txBody>
                  <a:tcPr marL="12309" marR="12309" marT="1230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5075571"/>
                  </a:ext>
                </a:extLst>
              </a:tr>
            </a:tbl>
          </a:graphicData>
        </a:graphic>
      </p:graphicFrame>
      <p:sp>
        <p:nvSpPr>
          <p:cNvPr id="3" name="CaixaDeTexto 2">
            <a:extLst>
              <a:ext uri="{FF2B5EF4-FFF2-40B4-BE49-F238E27FC236}">
                <a16:creationId xmlns:a16="http://schemas.microsoft.com/office/drawing/2014/main" id="{E4D9FF51-A186-90C1-4352-04B45649D663}"/>
              </a:ext>
            </a:extLst>
          </p:cNvPr>
          <p:cNvSpPr txBox="1"/>
          <p:nvPr/>
        </p:nvSpPr>
        <p:spPr>
          <a:xfrm>
            <a:off x="608452" y="8778967"/>
            <a:ext cx="8091712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In order to further analyze the involvement of NFAT regulation in the genes discovered to be responsive to this pathway in qPCR we made a multiple-sequence alignment analysis to detect evolutionarily conserved NFAT transcription factor binding sites. We used Mulan server together with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multiTF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program for comparing multiple finished-quality sequences to identify functional elements conserved over evolutionary time (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Ovcharenko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I Loots GG Genome Res. 2005). We conducted two comparative genome sequence analysis in five mammalian species including, humans, mouse, chimps, rhesus and rat or only in human and mouse. SYN 1 gene has at least two well conserved putative NFAT biding site in their promoter region in all five species (Species: Homo X Mouse X Chimp X Rhesus X Rat and position from the transcription start, respectively:</a:t>
            </a:r>
          </a:p>
          <a:p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1 V$NFAT_Q4_01 + 643-652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gtGGACActt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+ 631-640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gtGGACActt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+ 643-652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gtGGACActt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+ 643-652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gtGGACActt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+ 625-634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gtGGACActt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</a:p>
          <a:p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2 V$NFAT_Q4_01 + 953-962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atGGAGAaac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+ 907-916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aaGGAAActc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+ 951-960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atGGAGAaac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+ 955-964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atGGAGAaac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+ 873-882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aaGGAAActc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). Consistently, the NFAT non-responsive genes promoters displayed no conserved putative NFAT biding site even when only human and mouse promoter were aligned. We considered promoter region for SYN 1 gene a -3000bp and for non-regulated genes a -6000bp in relation to the transcription start. The larger promoter region considered for NFAT non-regulated regions was to further demonstrate the inexistence of a conserved putative NFAT biding site in these genes. </a:t>
            </a:r>
            <a:endParaRPr lang="pt-BR" sz="1400" dirty="0"/>
          </a:p>
        </p:txBody>
      </p:sp>
      <p:sp>
        <p:nvSpPr>
          <p:cNvPr id="4" name="CaixaDeTexto 3">
            <a:extLst>
              <a:ext uri="{FF2B5EF4-FFF2-40B4-BE49-F238E27FC236}">
                <a16:creationId xmlns:a16="http://schemas.microsoft.com/office/drawing/2014/main" id="{F4262EB9-549B-8CFE-907E-51CD7027F182}"/>
              </a:ext>
            </a:extLst>
          </p:cNvPr>
          <p:cNvSpPr txBox="1"/>
          <p:nvPr/>
        </p:nvSpPr>
        <p:spPr>
          <a:xfrm>
            <a:off x="255514" y="369651"/>
            <a:ext cx="26926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lementary </a:t>
            </a:r>
            <a:r>
              <a:rPr lang="en-US" sz="2000" b="1"/>
              <a:t>Table 2: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406467170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69</TotalTime>
  <Words>1217</Words>
  <Application>Microsoft Macintosh PowerPoint</Application>
  <PresentationFormat>Papel A3 (297 x 420 mm)</PresentationFormat>
  <Paragraphs>491</Paragraphs>
  <Slides>5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ema do Office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Bruno Robbs</dc:creator>
  <cp:lastModifiedBy>Ricardo Santanna</cp:lastModifiedBy>
  <cp:revision>3</cp:revision>
  <dcterms:created xsi:type="dcterms:W3CDTF">2022-07-20T14:40:22Z</dcterms:created>
  <dcterms:modified xsi:type="dcterms:W3CDTF">2023-02-24T15:44:36Z</dcterms:modified>
</cp:coreProperties>
</file>